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-1694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76200" y="1371600"/>
            <a:ext cx="664060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rimer sequences for RT-PCR, </a:t>
            </a:r>
            <a:r>
              <a:rPr lang="en-US" altLang="ko-KR" sz="1400" b="1" dirty="0" err="1" smtClean="0">
                <a:latin typeface="Times New Roman" pitchFamily="18" charset="0"/>
                <a:cs typeface="Times New Roman" pitchFamily="18" charset="0"/>
              </a:rPr>
              <a:t>ChIP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 assay and gene cloning analyses in human cells</a:t>
            </a:r>
            <a:endParaRPr lang="ko-KR" alt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71"/>
          <p:cNvGrpSpPr/>
          <p:nvPr/>
        </p:nvGrpSpPr>
        <p:grpSpPr>
          <a:xfrm>
            <a:off x="10330" y="2641274"/>
            <a:ext cx="6923870" cy="3530926"/>
            <a:chOff x="10330" y="3270872"/>
            <a:chExt cx="6923870" cy="3530926"/>
          </a:xfrm>
        </p:grpSpPr>
        <p:sp>
          <p:nvSpPr>
            <p:cNvPr id="31" name="Rectangle 12"/>
            <p:cNvSpPr/>
            <p:nvPr/>
          </p:nvSpPr>
          <p:spPr>
            <a:xfrm>
              <a:off x="10330" y="5552781"/>
              <a:ext cx="136127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b="1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NF</a:t>
              </a:r>
              <a:r>
                <a:rPr lang="en-US" sz="900" b="1" dirty="0" err="1" smtClean="0">
                  <a:solidFill>
                    <a:srgbClr val="000000"/>
                  </a:solidFill>
                  <a:latin typeface="Symbol" pitchFamily="18" charset="2"/>
                  <a:cs typeface="Times New Roman" pitchFamily="18" charset="0"/>
                </a:rPr>
                <a:t>k</a:t>
              </a:r>
              <a:r>
                <a:rPr lang="en-US" sz="900" b="1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n-US" sz="900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-response element</a:t>
              </a:r>
            </a:p>
            <a:p>
              <a:pPr algn="ctr" fontAlgn="b"/>
              <a:r>
                <a:rPr lang="en-US" sz="900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of </a:t>
              </a:r>
              <a:r>
                <a:rPr lang="en-US" sz="900" b="1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nSOD</a:t>
              </a:r>
              <a:r>
                <a:rPr lang="en-US" sz="900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gene </a:t>
              </a:r>
              <a:endParaRPr lang="en-US" sz="9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Rectangle 13"/>
            <p:cNvSpPr/>
            <p:nvPr/>
          </p:nvSpPr>
          <p:spPr>
            <a:xfrm>
              <a:off x="133794" y="6076002"/>
              <a:ext cx="9412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900" dirty="0" smtClean="0">
                  <a:solidFill>
                    <a:srgbClr val="000000"/>
                  </a:solidFill>
                  <a:latin typeface="Symbol" pitchFamily="18" charset="2"/>
                  <a:cs typeface="Times New Roman" pitchFamily="18" charset="0"/>
                </a:rPr>
                <a:t>k</a:t>
              </a:r>
              <a:r>
                <a:rPr lang="da-DK" sz="9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B-RE for ChIP</a:t>
              </a:r>
              <a:endParaRPr lang="da-DK" sz="9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Rectangle 14"/>
            <p:cNvSpPr/>
            <p:nvPr/>
          </p:nvSpPr>
          <p:spPr>
            <a:xfrm>
              <a:off x="37613" y="6457002"/>
              <a:ext cx="113364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900" dirty="0" smtClean="0">
                  <a:solidFill>
                    <a:srgbClr val="000000"/>
                  </a:solidFill>
                  <a:latin typeface="Symbol" pitchFamily="18" charset="2"/>
                  <a:cs typeface="Times New Roman" pitchFamily="18" charset="0"/>
                </a:rPr>
                <a:t>k</a:t>
              </a:r>
              <a:r>
                <a:rPr lang="da-DK" sz="9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B-RE for Cloning  </a:t>
              </a:r>
              <a:endParaRPr lang="da-DK" sz="9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Rectangle 23"/>
            <p:cNvSpPr/>
            <p:nvPr/>
          </p:nvSpPr>
          <p:spPr>
            <a:xfrm>
              <a:off x="2230881" y="5629726"/>
              <a:ext cx="102463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b="1" dirty="0" smtClean="0">
                  <a:solidFill>
                    <a:srgbClr val="000000"/>
                  </a:solidFill>
                  <a:latin typeface="Times New Roman"/>
                </a:rPr>
                <a:t>Forward primer </a:t>
              </a:r>
              <a:endParaRPr lang="en-US" sz="900" b="1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" name="Rectangle 24"/>
            <p:cNvSpPr/>
            <p:nvPr/>
          </p:nvSpPr>
          <p:spPr>
            <a:xfrm>
              <a:off x="4982096" y="5629726"/>
              <a:ext cx="100860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b="1" dirty="0" smtClean="0">
                  <a:solidFill>
                    <a:srgbClr val="000000"/>
                  </a:solidFill>
                  <a:latin typeface="Times New Roman"/>
                </a:rPr>
                <a:t>Reverse primer  </a:t>
              </a:r>
              <a:endParaRPr lang="en-US" sz="900" b="1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" name="Rectangle 25"/>
            <p:cNvSpPr/>
            <p:nvPr/>
          </p:nvSpPr>
          <p:spPr>
            <a:xfrm>
              <a:off x="1592885" y="6076002"/>
              <a:ext cx="230063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CCTGATTGTGTTTGAAGTAAATG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" name="Rectangle 26"/>
            <p:cNvSpPr/>
            <p:nvPr/>
          </p:nvSpPr>
          <p:spPr>
            <a:xfrm>
              <a:off x="4441884" y="6076002"/>
              <a:ext cx="208903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TCTGATTCCACAAGTAAAGG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" name="Rectangle 27"/>
            <p:cNvSpPr/>
            <p:nvPr/>
          </p:nvSpPr>
          <p:spPr>
            <a:xfrm>
              <a:off x="1143000" y="6457002"/>
              <a:ext cx="320040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dirty="0" smtClean="0">
                  <a:latin typeface="Times New Roman"/>
                </a:rPr>
                <a:t>5’-ACCTCGAGTGATTGTGTTTGAAGTAAATG-3’ </a:t>
              </a:r>
              <a:endParaRPr lang="en-US" sz="900" dirty="0"/>
            </a:p>
          </p:txBody>
        </p:sp>
        <p:sp>
          <p:nvSpPr>
            <p:cNvPr id="39" name="Rectangle 28"/>
            <p:cNvSpPr/>
            <p:nvPr/>
          </p:nvSpPr>
          <p:spPr>
            <a:xfrm>
              <a:off x="4038600" y="6457002"/>
              <a:ext cx="289560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en-US" sz="900" dirty="0" smtClean="0">
                  <a:latin typeface="Times New Roman"/>
                </a:rPr>
                <a:t>5’-AAAAAGCTTTGATTCCACAAGTAAAGG-3’ </a:t>
              </a:r>
              <a:endParaRPr lang="en-US" sz="900" dirty="0">
                <a:latin typeface="Times New Roman"/>
              </a:endParaRPr>
            </a:p>
          </p:txBody>
        </p:sp>
        <p:cxnSp>
          <p:nvCxnSpPr>
            <p:cNvPr id="40" name="Straight Connector 29"/>
            <p:cNvCxnSpPr/>
            <p:nvPr/>
          </p:nvCxnSpPr>
          <p:spPr>
            <a:xfrm flipV="1">
              <a:off x="121920" y="5466402"/>
              <a:ext cx="65836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30"/>
            <p:cNvCxnSpPr/>
            <p:nvPr/>
          </p:nvCxnSpPr>
          <p:spPr>
            <a:xfrm flipV="1">
              <a:off x="121920" y="5999802"/>
              <a:ext cx="65836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31"/>
            <p:cNvCxnSpPr/>
            <p:nvPr/>
          </p:nvCxnSpPr>
          <p:spPr>
            <a:xfrm flipV="1">
              <a:off x="121920" y="6801798"/>
              <a:ext cx="65836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3"/>
            <p:cNvCxnSpPr/>
            <p:nvPr/>
          </p:nvCxnSpPr>
          <p:spPr>
            <a:xfrm flipV="1">
              <a:off x="121920" y="3270872"/>
              <a:ext cx="65836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4"/>
            <p:cNvCxnSpPr/>
            <p:nvPr/>
          </p:nvCxnSpPr>
          <p:spPr>
            <a:xfrm flipV="1">
              <a:off x="121920" y="3637602"/>
              <a:ext cx="65836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61420" y="3359151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Genes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42102" y="3359151"/>
              <a:ext cx="10021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Forward Primer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993317" y="3359151"/>
              <a:ext cx="9861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Reverse Primer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Rectangle 8"/>
            <p:cNvSpPr/>
            <p:nvPr/>
          </p:nvSpPr>
          <p:spPr>
            <a:xfrm>
              <a:off x="316536" y="3749693"/>
              <a:ext cx="57579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/>
              <a:r>
                <a:rPr lang="en-US" sz="900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nSOD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Rectangle 9"/>
            <p:cNvSpPr/>
            <p:nvPr/>
          </p:nvSpPr>
          <p:spPr>
            <a:xfrm>
              <a:off x="310926" y="4017822"/>
              <a:ext cx="58701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/>
              <a:r>
                <a:rPr lang="en-US" sz="9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p21</a:t>
              </a:r>
              <a:r>
                <a:rPr lang="en-US" sz="900" baseline="300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WAF1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10"/>
            <p:cNvSpPr/>
            <p:nvPr/>
          </p:nvSpPr>
          <p:spPr>
            <a:xfrm>
              <a:off x="298903" y="4322622"/>
              <a:ext cx="611065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/>
              <a:r>
                <a:rPr lang="en-US" sz="9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APDH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Rectangle 11"/>
            <p:cNvSpPr/>
            <p:nvPr/>
          </p:nvSpPr>
          <p:spPr>
            <a:xfrm>
              <a:off x="338978" y="4627422"/>
              <a:ext cx="530915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BTG2  </a:t>
              </a:r>
              <a:endParaRPr lang="en-US" sz="9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Rectangle 15"/>
            <p:cNvSpPr/>
            <p:nvPr/>
          </p:nvSpPr>
          <p:spPr>
            <a:xfrm>
              <a:off x="1711508" y="3749693"/>
              <a:ext cx="206338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CTTCAGCCTGCACTGAAGTT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Rectangle 16"/>
            <p:cNvSpPr/>
            <p:nvPr/>
          </p:nvSpPr>
          <p:spPr>
            <a:xfrm>
              <a:off x="4438678" y="3749693"/>
              <a:ext cx="209544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CTGAAGGTAGTAAGCGTGCT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Rectangle 17"/>
            <p:cNvSpPr/>
            <p:nvPr/>
          </p:nvSpPr>
          <p:spPr>
            <a:xfrm>
              <a:off x="1711508" y="4017822"/>
              <a:ext cx="206338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′-CGACTGTGATGCGCTAATGG-3′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Rectangle 18"/>
            <p:cNvSpPr/>
            <p:nvPr/>
          </p:nvSpPr>
          <p:spPr>
            <a:xfrm>
              <a:off x="4502798" y="4017822"/>
              <a:ext cx="196720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′-CCGTTTTCGACCCTGAGAG-3′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Rectangle 19"/>
            <p:cNvSpPr/>
            <p:nvPr/>
          </p:nvSpPr>
          <p:spPr>
            <a:xfrm>
              <a:off x="1772422" y="4322622"/>
              <a:ext cx="194155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′-CCATGGAGAAGGCTGGGG-3′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Rectangle 20"/>
            <p:cNvSpPr/>
            <p:nvPr/>
          </p:nvSpPr>
          <p:spPr>
            <a:xfrm>
              <a:off x="4454708" y="4322622"/>
              <a:ext cx="206338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′-CAAAGTTGTCATGGATGACC-3′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Rectangle 21"/>
            <p:cNvSpPr/>
            <p:nvPr/>
          </p:nvSpPr>
          <p:spPr>
            <a:xfrm>
              <a:off x="1689066" y="4627422"/>
              <a:ext cx="210826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GCACTCACAGAGCACTACAA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Rectangle 22"/>
            <p:cNvSpPr/>
            <p:nvPr/>
          </p:nvSpPr>
          <p:spPr>
            <a:xfrm>
              <a:off x="4441884" y="4627422"/>
              <a:ext cx="208903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solidFill>
                    <a:srgbClr val="000000"/>
                  </a:solidFill>
                  <a:latin typeface="Times New Roman"/>
                </a:rPr>
                <a:t>5’-CTAGCTGGAGACTGCCATCA-3’  </a:t>
              </a:r>
              <a:endParaRPr lang="en-US" sz="9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96686" y="4923094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Akt1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96686" y="5208846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Akt2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01276" y="4923094"/>
              <a:ext cx="18838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GCTGGACGATAGCTTGGA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541270" y="4923094"/>
              <a:ext cx="18902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GATGACAGATAGCTGGTG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69216" y="5208846"/>
              <a:ext cx="19479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GGCCCCTGATGAGACTCTA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512416" y="5208846"/>
              <a:ext cx="19479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TCCTCAGTCGTGGAGGAGT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122" name="Rectangle 2"/>
          <p:cNvSpPr>
            <a:spLocks noChangeArrowheads="1"/>
          </p:cNvSpPr>
          <p:nvPr/>
        </p:nvSpPr>
        <p:spPr bwMode="auto">
          <a:xfrm>
            <a:off x="0" y="1033046"/>
            <a:ext cx="177805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 5:</a:t>
            </a:r>
            <a:endParaRPr lang="en-US" sz="28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eethi</dc:creator>
  <cp:lastModifiedBy>preet</cp:lastModifiedBy>
  <cp:revision>1</cp:revision>
  <dcterms:created xsi:type="dcterms:W3CDTF">2006-08-16T00:00:00Z</dcterms:created>
  <dcterms:modified xsi:type="dcterms:W3CDTF">2013-08-24T15:09:01Z</dcterms:modified>
</cp:coreProperties>
</file>